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2" r:id="rId2"/>
    <p:sldId id="263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85" autoAdjust="0"/>
    <p:restoredTop sz="94660"/>
  </p:normalViewPr>
  <p:slideViewPr>
    <p:cSldViewPr snapToGrid="0">
      <p:cViewPr varScale="1">
        <p:scale>
          <a:sx n="87" d="100"/>
          <a:sy n="87" d="100"/>
        </p:scale>
        <p:origin x="276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467067-8268-4348-A5B6-4C4BF948E568}" type="datetimeFigureOut">
              <a:rPr lang="en-DE" smtClean="0"/>
              <a:t>29/11/2023</a:t>
            </a:fld>
            <a:endParaRPr lang="en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5965B2-C7DB-4E58-A929-FEDBA6215C0F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4694539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b="1" dirty="0"/>
              <a:t>Figure S1: zCry4</a:t>
            </a:r>
            <a:r>
              <a:rPr lang="en-GB" b="1" baseline="0" dirty="0"/>
              <a:t> can be stably expressed in clock neurons.</a:t>
            </a:r>
            <a:r>
              <a:rPr lang="en-GB" baseline="0" dirty="0"/>
              <a:t>  Whole-mount brain preparations of adult flies were co-treated with antibodies against the HA-Tag (C-terminal Tag of zCry4, see Materials and Methods) and Pigment Dispersing Factor (PDF). Anti-PDF labels the four small (s-</a:t>
            </a:r>
            <a:r>
              <a:rPr lang="en-GB" baseline="0" dirty="0" err="1"/>
              <a:t>LNv</a:t>
            </a:r>
            <a:r>
              <a:rPr lang="en-GB" baseline="0" dirty="0"/>
              <a:t>) and four large (l-</a:t>
            </a:r>
            <a:r>
              <a:rPr lang="en-GB" baseline="0" dirty="0" err="1"/>
              <a:t>LNv</a:t>
            </a:r>
            <a:r>
              <a:rPr lang="en-GB" baseline="0" dirty="0"/>
              <a:t>) ventral lateral clock neurons. The l-</a:t>
            </a:r>
            <a:r>
              <a:rPr lang="en-GB" baseline="0" dirty="0" err="1"/>
              <a:t>LNv</a:t>
            </a:r>
            <a:r>
              <a:rPr lang="en-GB" baseline="0" dirty="0"/>
              <a:t> are shown in the images above. Note that only the l-</a:t>
            </a:r>
            <a:r>
              <a:rPr lang="en-GB" baseline="0" dirty="0" err="1"/>
              <a:t>LNv</a:t>
            </a:r>
            <a:r>
              <a:rPr lang="en-GB" baseline="0" dirty="0"/>
              <a:t> of flies containing both </a:t>
            </a:r>
            <a:r>
              <a:rPr lang="en-GB" i="1" baseline="0" dirty="0"/>
              <a:t>tim-gal4</a:t>
            </a:r>
            <a:r>
              <a:rPr lang="en-GB" i="0" baseline="0" dirty="0"/>
              <a:t> and </a:t>
            </a:r>
            <a:r>
              <a:rPr lang="en-GB" i="1" baseline="0" dirty="0"/>
              <a:t>UAS-zCry4</a:t>
            </a:r>
            <a:r>
              <a:rPr lang="en-GB" i="0" baseline="0" dirty="0"/>
              <a:t> transgenes are labelled by anti-HA, demonstrating that these flies express zCry4. Scale bar = </a:t>
            </a:r>
            <a:r>
              <a:rPr lang="en-GB" i="0" baseline="0" dirty="0">
                <a:sym typeface="Symbol" panose="05050102010706020507" pitchFamily="18" charset="2"/>
              </a:rPr>
              <a:t>m</a:t>
            </a:r>
            <a:r>
              <a:rPr lang="en-GB" i="0" baseline="0" dirty="0"/>
              <a:t>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6F0841-A111-48B8-8933-1180C2570B6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87371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F9C7B-5F00-4B47-A97E-E11C98B64718}" type="datetimeFigureOut">
              <a:rPr lang="en-DE" smtClean="0"/>
              <a:t>29/11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CDDC6-4D8A-4288-8279-133B15800C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80642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F9C7B-5F00-4B47-A97E-E11C98B64718}" type="datetimeFigureOut">
              <a:rPr lang="en-DE" smtClean="0"/>
              <a:t>29/11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CDDC6-4D8A-4288-8279-133B15800C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16817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F9C7B-5F00-4B47-A97E-E11C98B64718}" type="datetimeFigureOut">
              <a:rPr lang="en-DE" smtClean="0"/>
              <a:t>29/11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CDDC6-4D8A-4288-8279-133B15800C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59407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F9C7B-5F00-4B47-A97E-E11C98B64718}" type="datetimeFigureOut">
              <a:rPr lang="en-DE" smtClean="0"/>
              <a:t>29/11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CDDC6-4D8A-4288-8279-133B15800C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65627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F9C7B-5F00-4B47-A97E-E11C98B64718}" type="datetimeFigureOut">
              <a:rPr lang="en-DE" smtClean="0"/>
              <a:t>29/11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CDDC6-4D8A-4288-8279-133B15800C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98988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F9C7B-5F00-4B47-A97E-E11C98B64718}" type="datetimeFigureOut">
              <a:rPr lang="en-DE" smtClean="0"/>
              <a:t>29/11/2023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CDDC6-4D8A-4288-8279-133B15800C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069149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F9C7B-5F00-4B47-A97E-E11C98B64718}" type="datetimeFigureOut">
              <a:rPr lang="en-DE" smtClean="0"/>
              <a:t>29/11/2023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CDDC6-4D8A-4288-8279-133B15800C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40044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F9C7B-5F00-4B47-A97E-E11C98B64718}" type="datetimeFigureOut">
              <a:rPr lang="en-DE" smtClean="0"/>
              <a:t>29/11/2023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CDDC6-4D8A-4288-8279-133B15800C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179813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F9C7B-5F00-4B47-A97E-E11C98B64718}" type="datetimeFigureOut">
              <a:rPr lang="en-DE" smtClean="0"/>
              <a:t>29/11/2023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CDDC6-4D8A-4288-8279-133B15800C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43586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F9C7B-5F00-4B47-A97E-E11C98B64718}" type="datetimeFigureOut">
              <a:rPr lang="en-DE" smtClean="0"/>
              <a:t>29/11/2023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CDDC6-4D8A-4288-8279-133B15800C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172634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F9C7B-5F00-4B47-A97E-E11C98B64718}" type="datetimeFigureOut">
              <a:rPr lang="en-DE" smtClean="0"/>
              <a:t>29/11/2023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CDDC6-4D8A-4288-8279-133B15800C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30092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EF9C7B-5F00-4B47-A97E-E11C98B64718}" type="datetimeFigureOut">
              <a:rPr lang="en-DE" smtClean="0"/>
              <a:t>29/11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3CDDC6-4D8A-4288-8279-133B15800C3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64710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3426133" y="1363163"/>
            <a:ext cx="2160160" cy="1440000"/>
            <a:chOff x="704365" y="1474204"/>
            <a:chExt cx="2160160" cy="1440000"/>
          </a:xfrm>
        </p:grpSpPr>
        <p:pic>
          <p:nvPicPr>
            <p:cNvPr id="5" name="Picture 4" descr="PDF.tif"/>
            <p:cNvPicPr>
              <a:picLocks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 rot="16200000">
              <a:off x="344365" y="1834204"/>
              <a:ext cx="1440000" cy="720000"/>
            </a:xfrm>
            <a:prstGeom prst="rect">
              <a:avLst/>
            </a:prstGeom>
          </p:spPr>
        </p:pic>
        <p:pic>
          <p:nvPicPr>
            <p:cNvPr id="6" name="Picture 5" descr="PDF-HA.tif"/>
            <p:cNvPicPr>
              <a:picLocks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 rot="16200000">
              <a:off x="1064445" y="1834204"/>
              <a:ext cx="1440000" cy="720000"/>
            </a:xfrm>
            <a:prstGeom prst="rect">
              <a:avLst/>
            </a:prstGeom>
          </p:spPr>
        </p:pic>
        <p:cxnSp>
          <p:nvCxnSpPr>
            <p:cNvPr id="15" name="Straight Connector 14"/>
            <p:cNvCxnSpPr/>
            <p:nvPr/>
          </p:nvCxnSpPr>
          <p:spPr>
            <a:xfrm flipH="1">
              <a:off x="776373" y="2842356"/>
              <a:ext cx="28803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Picture 16" descr="1-2.tif"/>
            <p:cNvPicPr preferRelativeResize="0">
              <a:picLocks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 rot="16200000">
              <a:off x="1784525" y="1834204"/>
              <a:ext cx="1440000" cy="720000"/>
            </a:xfrm>
            <a:prstGeom prst="rect">
              <a:avLst/>
            </a:prstGeom>
          </p:spPr>
        </p:pic>
      </p:grpSp>
      <p:grpSp>
        <p:nvGrpSpPr>
          <p:cNvPr id="21" name="Group 20"/>
          <p:cNvGrpSpPr/>
          <p:nvPr/>
        </p:nvGrpSpPr>
        <p:grpSpPr>
          <a:xfrm>
            <a:off x="1265893" y="1363163"/>
            <a:ext cx="2150235" cy="1487373"/>
            <a:chOff x="4376773" y="1474044"/>
            <a:chExt cx="2150235" cy="1487373"/>
          </a:xfrm>
        </p:grpSpPr>
        <p:pic>
          <p:nvPicPr>
            <p:cNvPr id="7" name="Picture 6" descr="3.33 s-3.tif"/>
            <p:cNvPicPr>
              <a:picLocks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 rot="16200000">
              <a:off x="4755135" y="1780238"/>
              <a:ext cx="1440000" cy="827612"/>
            </a:xfrm>
            <a:prstGeom prst="rect">
              <a:avLst/>
            </a:prstGeom>
          </p:spPr>
        </p:pic>
        <p:pic>
          <p:nvPicPr>
            <p:cNvPr id="8" name="Picture 7" descr="3.33 s-2.tif"/>
            <p:cNvPicPr>
              <a:picLocks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 rot="16200000">
              <a:off x="4016773" y="1834204"/>
              <a:ext cx="1440000" cy="72000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4772738" y="268441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solidFill>
                    <a:srgbClr val="FF0000"/>
                  </a:solidFill>
                </a:rPr>
                <a:t>HA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420810" y="2680904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solidFill>
                    <a:srgbClr val="7030A0"/>
                  </a:solidFill>
                </a:rPr>
                <a:t>PDF</a:t>
              </a:r>
            </a:p>
          </p:txBody>
        </p:sp>
        <p:cxnSp>
          <p:nvCxnSpPr>
            <p:cNvPr id="16" name="Straight Connector 15"/>
            <p:cNvCxnSpPr/>
            <p:nvPr/>
          </p:nvCxnSpPr>
          <p:spPr>
            <a:xfrm flipH="1">
              <a:off x="4448781" y="2842356"/>
              <a:ext cx="288032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8" name="Picture 17" descr="2-4.tif"/>
            <p:cNvPicPr preferRelativeResize="0">
              <a:picLocks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 rot="16200000">
              <a:off x="5456893" y="1906252"/>
              <a:ext cx="1440160" cy="576064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5806928" y="2680903"/>
              <a:ext cx="7200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200" dirty="0">
                  <a:solidFill>
                    <a:schemeClr val="bg1"/>
                  </a:solidFill>
                </a:rPr>
                <a:t>Merge</a:t>
              </a:r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6103113" y="0"/>
            <a:ext cx="754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igure S1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779278" y="1038790"/>
            <a:ext cx="8873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+/</a:t>
            </a:r>
            <a:r>
              <a:rPr lang="en-GB" sz="1200" i="1" dirty="0"/>
              <a:t>UAS-cry4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861153" y="1038790"/>
            <a:ext cx="1336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/>
              <a:t>tim-gal4</a:t>
            </a:r>
            <a:r>
              <a:rPr lang="en-GB" sz="1200" dirty="0"/>
              <a:t>/</a:t>
            </a:r>
            <a:r>
              <a:rPr lang="en-GB" sz="1200" i="1" dirty="0"/>
              <a:t>UAS-cry4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4A3FED69-3CE7-DB69-2421-7CF6551651C1}"/>
              </a:ext>
            </a:extLst>
          </p:cNvPr>
          <p:cNvCxnSpPr>
            <a:cxnSpLocks/>
          </p:cNvCxnSpPr>
          <p:nvPr/>
        </p:nvCxnSpPr>
        <p:spPr>
          <a:xfrm>
            <a:off x="4379873" y="1988496"/>
            <a:ext cx="102416" cy="83446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D9BBCA81-E4C6-7B42-F203-5574B39D359D}"/>
              </a:ext>
            </a:extLst>
          </p:cNvPr>
          <p:cNvCxnSpPr>
            <a:cxnSpLocks/>
          </p:cNvCxnSpPr>
          <p:nvPr/>
        </p:nvCxnSpPr>
        <p:spPr>
          <a:xfrm>
            <a:off x="3685980" y="1984135"/>
            <a:ext cx="102416" cy="83446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833015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857232" y="1595415"/>
          <a:ext cx="5357851" cy="7361957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141766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0883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023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8826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52284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81656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Genoty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n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>
                          <a:latin typeface="Arial" pitchFamily="34" charset="0"/>
                          <a:cs typeface="Arial" pitchFamily="34" charset="0"/>
                        </a:rPr>
                        <a:t>Rhythmic </a:t>
                      </a:r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flies(%)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RS ±SEM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Period(hr) ±SEM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463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right</a:t>
                      </a:r>
                      <a:r>
                        <a:rPr lang="en-US" altLang="zh-CN" sz="700" b="1" baseline="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light (</a:t>
                      </a:r>
                      <a:r>
                        <a:rPr lang="zh-CN" altLang="en-US" sz="700" b="1" baseline="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～</a:t>
                      </a:r>
                      <a:r>
                        <a:rPr lang="en-US" altLang="zh-CN" sz="700" b="1" baseline="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500lux)</a:t>
                      </a:r>
                      <a:endParaRPr lang="zh-CN" altLang="en-US" sz="7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y w ;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s-tim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(12.5)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1.2±0.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8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ry</a:t>
                      </a:r>
                      <a:r>
                        <a:rPr lang="en-US" altLang="zh-CN" sz="700" b="0" i="1" baseline="3000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6(75)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.4±0.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4.1±0.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k-gal4/+;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ry</a:t>
                      </a:r>
                      <a:r>
                        <a:rPr lang="en-US" altLang="zh-CN" sz="700" b="0" i="1" baseline="3000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0(62.5)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.2±0.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3.5±0.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k-gal4/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ry;cry</a:t>
                      </a:r>
                      <a:r>
                        <a:rPr lang="en-US" altLang="zh-CN" sz="700" b="0" i="1" baseline="3000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2(12.5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）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1.4±0.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2.4±1.6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k-gal4/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puCry;cry</a:t>
                      </a:r>
                      <a:r>
                        <a:rPr lang="en-US" altLang="zh-CN" sz="700" b="0" i="1" baseline="3000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（</a:t>
                      </a:r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85.7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）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3.3±0.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4.2±0.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k-gal4/cry1a;cry</a:t>
                      </a:r>
                      <a:r>
                        <a:rPr lang="en-US" altLang="zh-CN" sz="700" b="0" i="1" baseline="3000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No data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k-gal4/cry3;cry</a:t>
                      </a:r>
                      <a:r>
                        <a:rPr lang="en-US" altLang="zh-CN" sz="700" b="0" i="1" baseline="3000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（</a:t>
                      </a:r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68.8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）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.3±0.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4.5±0.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k-gal4/cry4;cry</a:t>
                      </a:r>
                      <a:r>
                        <a:rPr lang="en-US" altLang="zh-CN" sz="700" b="0" i="1" baseline="3000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（</a:t>
                      </a:r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87.5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）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3.1±0.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3.8±0.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df-gal4/+;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ry</a:t>
                      </a:r>
                      <a:r>
                        <a:rPr lang="en-US" altLang="zh-CN" sz="700" b="0" i="1" baseline="3000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（</a:t>
                      </a:r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53.8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）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.2±0.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4.1±0.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df-gal4/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ry;cry</a:t>
                      </a:r>
                      <a:r>
                        <a:rPr lang="en-US" altLang="zh-CN" sz="700" b="0" i="1" baseline="3000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（</a:t>
                      </a:r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56.3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）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.0±0.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3.3±0.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df-gal4/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puCry;cry</a:t>
                      </a:r>
                      <a:r>
                        <a:rPr lang="en-US" altLang="zh-CN" sz="700" b="0" i="1" baseline="3000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（</a:t>
                      </a:r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93.3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）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3.6±0.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5.1±0.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df-gal4/cry1a;cry</a:t>
                      </a:r>
                      <a:r>
                        <a:rPr lang="en-US" altLang="zh-CN" sz="700" b="0" i="1" baseline="3000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ctr"/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700" b="0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 data</a:t>
                      </a:r>
                      <a:endParaRPr lang="zh-CN" altLang="en-US" sz="700" b="0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endParaRPr lang="zh-CN" altLang="en-US" sz="700" b="0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endParaRPr lang="zh-CN" altLang="en-US" sz="700" b="1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endParaRPr lang="zh-CN" altLang="en-US" sz="700" b="1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7969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df-gal4/cry3;cry</a:t>
                      </a:r>
                      <a:r>
                        <a:rPr lang="en-US" altLang="zh-CN" sz="700" b="0" i="1" baseline="3000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（</a:t>
                      </a:r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68.8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）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3.2±0.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5.4±0.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df-gal4/cry4;cry</a:t>
                      </a:r>
                      <a:r>
                        <a:rPr lang="en-US" altLang="zh-CN" sz="700" b="0" i="1" baseline="3000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（</a:t>
                      </a:r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85.7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）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3.6±0.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4.7±0.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296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1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ow</a:t>
                      </a:r>
                      <a:r>
                        <a:rPr lang="en-US" altLang="zh-CN" sz="700" b="1" i="1" baseline="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1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ight (</a:t>
                      </a:r>
                      <a:r>
                        <a:rPr lang="zh-CN" altLang="en-US" sz="700" b="1" baseline="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～</a:t>
                      </a:r>
                      <a:r>
                        <a:rPr lang="en-US" altLang="zh-CN" sz="700" b="1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00lux</a:t>
                      </a:r>
                      <a:r>
                        <a:rPr lang="zh-CN" altLang="en-US" sz="700" b="1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）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>
                        <a:lumMod val="50000"/>
                        <a:lumOff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y w ;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s-tim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2(18.1)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1.1±0.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5.8±1.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y w;</a:t>
                      </a:r>
                      <a:r>
                        <a:rPr lang="en-US" altLang="zh-CN" sz="700" b="0" i="1" baseline="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700" b="0" i="1" baseline="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s-tim;cry</a:t>
                      </a:r>
                      <a:r>
                        <a:rPr lang="en-US" altLang="zh-CN" sz="700" b="0" i="1" baseline="3000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baseline="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6(60)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1.7±0.7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3.7±0.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y w;</a:t>
                      </a:r>
                      <a:r>
                        <a:rPr lang="en-US" altLang="zh-CN" sz="700" b="0" i="1" baseline="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s-</a:t>
                      </a:r>
                      <a:r>
                        <a:rPr lang="en-US" altLang="zh-CN" sz="700" b="0" i="1" baseline="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tim;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ry</a:t>
                      </a:r>
                      <a:r>
                        <a:rPr lang="en-US" altLang="zh-CN" sz="700" b="0" i="1" baseline="3000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6(75)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.9±0.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3.8±0.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k-gal4/+;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ry</a:t>
                      </a:r>
                      <a:r>
                        <a:rPr lang="en-US" altLang="zh-CN" sz="700" b="0" i="1" baseline="3000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8(100)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4.2±0.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4.3±0.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k-gal4/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ry;cry</a:t>
                      </a:r>
                      <a:r>
                        <a:rPr lang="en-US" altLang="zh-CN" sz="700" b="0" i="1" baseline="3000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2(14.2)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1.1±0.4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3.5±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k-gal4/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puCry;cry</a:t>
                      </a:r>
                      <a:r>
                        <a:rPr lang="en-US" altLang="zh-CN" sz="700" b="0" i="1" baseline="30000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2(100)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3.6±0.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4.4±0.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k-gal4/cry1a;cry</a:t>
                      </a:r>
                      <a:r>
                        <a:rPr lang="en-US" altLang="zh-CN" sz="700" b="0" i="1" baseline="3000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2(92.3)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3.1±0.5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4.1±0.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k-gal4/cry3;cry</a:t>
                      </a:r>
                      <a:r>
                        <a:rPr lang="en-US" altLang="zh-CN" sz="700" b="0" i="1" baseline="3000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5(93.8)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3.7±0.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4.7±0.2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8617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i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k-gal4/cry4</a:t>
                      </a:r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;cry</a:t>
                      </a:r>
                      <a:r>
                        <a:rPr lang="en-US" altLang="zh-CN" sz="700" b="0" i="1" baseline="3000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r>
                        <a:rPr lang="en-US" altLang="zh-CN" sz="700" b="0" i="1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s</a:t>
                      </a:r>
                      <a:endParaRPr lang="zh-CN" altLang="en-US" sz="700" b="0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endParaRPr lang="zh-CN" altLang="en-US" sz="7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6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（</a:t>
                      </a:r>
                      <a:r>
                        <a:rPr lang="en-US" altLang="zh-CN" sz="700" b="0" dirty="0">
                          <a:latin typeface="Arial" pitchFamily="34" charset="0"/>
                          <a:cs typeface="Arial" pitchFamily="34" charset="0"/>
                        </a:rPr>
                        <a:t>100</a:t>
                      </a:r>
                      <a:r>
                        <a:rPr lang="zh-CN" altLang="en-US" sz="700" b="0" dirty="0">
                          <a:latin typeface="Arial" pitchFamily="34" charset="0"/>
                          <a:cs typeface="Arial" pitchFamily="34" charset="0"/>
                        </a:rPr>
                        <a:t>）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4.3±0.3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700" dirty="0">
                          <a:latin typeface="Arial" pitchFamily="34" charset="0"/>
                          <a:cs typeface="Arial" pitchFamily="34" charset="0"/>
                        </a:rPr>
                        <a:t>24.0±0.01</a:t>
                      </a:r>
                      <a:endParaRPr lang="zh-CN" altLang="en-US" sz="7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928670" y="1166786"/>
            <a:ext cx="1071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able S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813994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72</Words>
  <Application>Microsoft Office PowerPoint</Application>
  <PresentationFormat>A4 Paper (210x297 mm)</PresentationFormat>
  <Paragraphs>125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lf Stanewsky</dc:creator>
  <cp:lastModifiedBy>Ralf Stanewsky</cp:lastModifiedBy>
  <cp:revision>1</cp:revision>
  <dcterms:created xsi:type="dcterms:W3CDTF">2023-11-29T13:36:13Z</dcterms:created>
  <dcterms:modified xsi:type="dcterms:W3CDTF">2023-11-29T13:37:03Z</dcterms:modified>
</cp:coreProperties>
</file>